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1B4A86-CCE1-454B-B095-808469AFDEA8}" type="datetime">
              <a:rPr b="0" lang="es-ES" sz="1200" spc="-1" strike="noStrike">
                <a:solidFill>
                  <a:srgbClr val="000000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8E3FAE-2342-475E-B835-8A8F71DE395A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 2- </a:t>
            </a:r>
            <a:r>
              <a:rPr b="1" i="1" lang="en-US" sz="1200" spc="-1" strike="noStrike">
                <a:solidFill>
                  <a:srgbClr val="000000"/>
                </a:solidFill>
                <a:latin typeface="Calibri"/>
              </a:rPr>
              <a:t>HeT-A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 sequences previously available on database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ame and accession number are given. X indicates i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HeT-A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elements are complete and if the sequence has been used in th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gag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/or 3’UTR fragment analysi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62F3DE-4170-497E-89D6-A0B33AFDB1B0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EF93A-551B-4ED0-B2CD-AA648E9006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818CDD-D2F7-4840-A939-80C43CC1B5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91F05-BFDF-4DA0-97DF-6CCF025433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2B84C-B891-4B50-8221-D12C6060E8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B5F25-8D3F-43EF-BC76-6175D20F98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85461-1BFF-4FFC-83A6-46B02BEBF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68DF7-E9C9-447D-9C07-88E21287A5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54636-CE91-4887-AD89-DA6C69DA31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62DD9-7054-4B1D-B851-E4BC496FDA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56A46-9EA2-4C10-9860-7B5C21C6A2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4C990-30E6-4CB2-8840-544C75FC06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214A1-ED1A-4505-8DE8-7AC23DE63E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E33E9C-1263-478D-A680-C06CDDDA4D43}" type="datetime">
              <a:rPr b="0" lang="es-ES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AD2701-A011-4700-BB2D-4B5F21C3964B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258920" y="189000"/>
          <a:ext cx="6567480" cy="6416640"/>
        </p:xfrm>
        <a:graphic>
          <a:graphicData uri="http://schemas.openxmlformats.org/drawingml/2006/table">
            <a:tbl>
              <a:tblPr/>
              <a:tblGrid>
                <a:gridCol w="1022400"/>
                <a:gridCol w="1368360"/>
                <a:gridCol w="1440000"/>
                <a:gridCol w="1512720"/>
                <a:gridCol w="1224000"/>
              </a:tblGrid>
              <a:tr h="2444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mplete ele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g fragment analyz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’UTR fragment analyz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ession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1D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J63522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B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77049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Zn-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0692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65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6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7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76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acks a bit of 5’UT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D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6813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L48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P000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87X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0328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Zn-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0692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PChrIII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02279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7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R627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010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J549609 -Chr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J5496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S-T-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069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S-T-A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069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TChrIII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J24335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T3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8420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T4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8420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L47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P000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L55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P000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L62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P000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L62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P0003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8T08:31:28Z</dcterms:created>
  <dc:creator>David</dc:creator>
  <dc:description/>
  <dc:language>en-US</dc:language>
  <cp:lastModifiedBy>Elena Casacuberta</cp:lastModifiedBy>
  <dcterms:modified xsi:type="dcterms:W3CDTF">2011-11-18T08:36:18Z</dcterms:modified>
  <cp:revision>314</cp:revision>
  <dc:subject/>
  <dc:title>Presentación de PowerPoint</dc:title>
</cp:coreProperties>
</file>